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1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163" r:id="rId2"/>
    <p:sldId id="2224" r:id="rId3"/>
    <p:sldId id="2161" r:id="rId4"/>
    <p:sldId id="2132" r:id="rId5"/>
    <p:sldId id="2131" r:id="rId6"/>
    <p:sldId id="2153" r:id="rId7"/>
    <p:sldId id="2150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9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421c3e623daf1d61/For%20Work/Radiation%20Oncology/2.&#12288;&#30740;&#31350;&#12539;&#30330;&#34920;/%5eN%2004_biology/&#35542;&#25991;_DrugScreening/BJC/STING%20KO&#23455;&#39443;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421c3e623daf1d61/For%20Work/Radiation%20Oncology/2.&#12288;&#30740;&#31350;&#12539;&#30330;&#34920;/%5eN%2004_biology/&#35542;&#25991;_DrugScreening/BJC/STING%20KO&#23455;&#39443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ug%20screen%20project\Analysis_Drug%20Screening4_0807&#35519;&#25972;&#29992;&#12289;&#20341;&#29992;&#34220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ug%20screen%20project\Analysis_Drug%20Screening4_0807&#35519;&#25972;&#29992;&#12289;&#20341;&#29992;&#34220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NFκB activity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0966426071741033"/>
          <c:y val="0.15745882290131075"/>
          <c:w val="0.84589129483814518"/>
          <c:h val="0.664541785544487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STING KO実験.xlsx]Sheet1'!$I$37</c:f>
              <c:strCache>
                <c:ptCount val="1"/>
                <c:pt idx="0">
                  <c:v>Wil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STING KO実験.xlsx]Sheet1'!$V$37:$W$37</c:f>
                <c:numCache>
                  <c:formatCode>General</c:formatCode>
                  <c:ptCount val="2"/>
                  <c:pt idx="0">
                    <c:v>1.5439232561469043</c:v>
                  </c:pt>
                  <c:pt idx="1">
                    <c:v>2.6062869873048276</c:v>
                  </c:pt>
                </c:numCache>
              </c:numRef>
            </c:plus>
            <c:minus>
              <c:numRef>
                <c:f>'[STING KO実験.xlsx]Sheet1'!$V$37:$W$37</c:f>
                <c:numCache>
                  <c:formatCode>General</c:formatCode>
                  <c:ptCount val="2"/>
                  <c:pt idx="0">
                    <c:v>1.5439232561469043</c:v>
                  </c:pt>
                  <c:pt idx="1">
                    <c:v>2.60628698730482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TING KO実験.xlsx]Sheet1'!$S$36:$T$36</c:f>
              <c:strCache>
                <c:ptCount val="2"/>
                <c:pt idx="0">
                  <c:v>NIR</c:v>
                </c:pt>
                <c:pt idx="1">
                  <c:v>IR</c:v>
                </c:pt>
              </c:strCache>
            </c:strRef>
          </c:cat>
          <c:val>
            <c:numRef>
              <c:f>'[STING KO実験.xlsx]Sheet1'!$S$37:$T$37</c:f>
              <c:numCache>
                <c:formatCode>General</c:formatCode>
                <c:ptCount val="2"/>
                <c:pt idx="0">
                  <c:v>31.048980227402257</c:v>
                </c:pt>
                <c:pt idx="1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514-4015-9E52-83F1B8C7E375}"/>
            </c:ext>
          </c:extLst>
        </c:ser>
        <c:ser>
          <c:idx val="1"/>
          <c:order val="1"/>
          <c:tx>
            <c:strRef>
              <c:f>'[STING KO実験.xlsx]Sheet1'!$I$38</c:f>
              <c:strCache>
                <c:ptCount val="1"/>
                <c:pt idx="0">
                  <c:v>STING-5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STING KO実験.xlsx]Sheet1'!$V$38:$W$38</c:f>
                <c:numCache>
                  <c:formatCode>General</c:formatCode>
                  <c:ptCount val="2"/>
                  <c:pt idx="0">
                    <c:v>2.5626264071698626</c:v>
                  </c:pt>
                  <c:pt idx="1">
                    <c:v>3.0124149803005347</c:v>
                  </c:pt>
                </c:numCache>
              </c:numRef>
            </c:plus>
            <c:minus>
              <c:numRef>
                <c:f>'[STING KO実験.xlsx]Sheet1'!$V$38:$W$38</c:f>
                <c:numCache>
                  <c:formatCode>General</c:formatCode>
                  <c:ptCount val="2"/>
                  <c:pt idx="0">
                    <c:v>2.5626264071698626</c:v>
                  </c:pt>
                  <c:pt idx="1">
                    <c:v>3.01241498030053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TING KO実験.xlsx]Sheet1'!$S$36:$T$36</c:f>
              <c:strCache>
                <c:ptCount val="2"/>
                <c:pt idx="0">
                  <c:v>NIR</c:v>
                </c:pt>
                <c:pt idx="1">
                  <c:v>IR</c:v>
                </c:pt>
              </c:strCache>
            </c:strRef>
          </c:cat>
          <c:val>
            <c:numRef>
              <c:f>'[STING KO実験.xlsx]Sheet1'!$S$38:$T$38</c:f>
              <c:numCache>
                <c:formatCode>General</c:formatCode>
                <c:ptCount val="2"/>
                <c:pt idx="0">
                  <c:v>16.480087562417705</c:v>
                </c:pt>
                <c:pt idx="1">
                  <c:v>24.3325910483351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514-4015-9E52-83F1B8C7E3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6819720"/>
        <c:axId val="1016820048"/>
      </c:barChart>
      <c:catAx>
        <c:axId val="1016819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16820048"/>
        <c:crosses val="autoZero"/>
        <c:auto val="1"/>
        <c:lblAlgn val="ctr"/>
        <c:lblOffset val="100"/>
        <c:noMultiLvlLbl val="0"/>
      </c:catAx>
      <c:valAx>
        <c:axId val="10168200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168197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ISRE activity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0602334167910964"/>
          <c:y val="0.1459528919355158"/>
          <c:w val="0.86753890437557124"/>
          <c:h val="0.6691384968995497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STING KO実験.xlsx]Sheet1'!$I$30</c:f>
              <c:strCache>
                <c:ptCount val="1"/>
                <c:pt idx="0">
                  <c:v>Wild 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STING KO実験.xlsx]Sheet1'!$V$30:$W$30</c:f>
                <c:numCache>
                  <c:formatCode>General</c:formatCode>
                  <c:ptCount val="2"/>
                  <c:pt idx="0">
                    <c:v>4.8045206744304059</c:v>
                  </c:pt>
                  <c:pt idx="1">
                    <c:v>8.1459310133748897</c:v>
                  </c:pt>
                </c:numCache>
              </c:numRef>
            </c:plus>
            <c:minus>
              <c:numRef>
                <c:f>'[STING KO実験.xlsx]Sheet1'!$V$30:$W$30</c:f>
                <c:numCache>
                  <c:formatCode>General</c:formatCode>
                  <c:ptCount val="2"/>
                  <c:pt idx="0">
                    <c:v>4.8045206744304059</c:v>
                  </c:pt>
                  <c:pt idx="1">
                    <c:v>8.14593101337488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TING KO実験.xlsx]Sheet1'!$S$29:$T$29</c:f>
              <c:strCache>
                <c:ptCount val="2"/>
                <c:pt idx="0">
                  <c:v>NIR</c:v>
                </c:pt>
                <c:pt idx="1">
                  <c:v>IR</c:v>
                </c:pt>
              </c:strCache>
            </c:strRef>
          </c:cat>
          <c:val>
            <c:numRef>
              <c:f>'[STING KO実験.xlsx]Sheet1'!$S$30:$T$30</c:f>
              <c:numCache>
                <c:formatCode>General</c:formatCode>
                <c:ptCount val="2"/>
                <c:pt idx="0">
                  <c:v>31.488060671243545</c:v>
                </c:pt>
                <c:pt idx="1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25-47A3-9BF9-37CB470B9F03}"/>
            </c:ext>
          </c:extLst>
        </c:ser>
        <c:ser>
          <c:idx val="1"/>
          <c:order val="1"/>
          <c:tx>
            <c:strRef>
              <c:f>'[STING KO実験.xlsx]Sheet1'!$I$31</c:f>
              <c:strCache>
                <c:ptCount val="1"/>
                <c:pt idx="0">
                  <c:v>STING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STING KO実験.xlsx]Sheet1'!$V$31:$W$31</c:f>
                <c:numCache>
                  <c:formatCode>General</c:formatCode>
                  <c:ptCount val="2"/>
                  <c:pt idx="0">
                    <c:v>0.49818994313686332</c:v>
                  </c:pt>
                  <c:pt idx="1">
                    <c:v>0.69970559199037285</c:v>
                  </c:pt>
                </c:numCache>
              </c:numRef>
            </c:plus>
            <c:minus>
              <c:numRef>
                <c:f>'[STING KO実験.xlsx]Sheet1'!$V$31:$W$31</c:f>
                <c:numCache>
                  <c:formatCode>General</c:formatCode>
                  <c:ptCount val="2"/>
                  <c:pt idx="0">
                    <c:v>0.49818994313686332</c:v>
                  </c:pt>
                  <c:pt idx="1">
                    <c:v>0.699705591990372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TING KO実験.xlsx]Sheet1'!$S$29:$T$29</c:f>
              <c:strCache>
                <c:ptCount val="2"/>
                <c:pt idx="0">
                  <c:v>NIR</c:v>
                </c:pt>
                <c:pt idx="1">
                  <c:v>IR</c:v>
                </c:pt>
              </c:strCache>
            </c:strRef>
          </c:cat>
          <c:val>
            <c:numRef>
              <c:f>'[STING KO実験.xlsx]Sheet1'!$S$31:$T$31</c:f>
              <c:numCache>
                <c:formatCode>General</c:formatCode>
                <c:ptCount val="2"/>
                <c:pt idx="0">
                  <c:v>1.3578030762447881</c:v>
                </c:pt>
                <c:pt idx="1">
                  <c:v>2.30041133128827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25-47A3-9BF9-37CB470B9F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06382096"/>
        <c:axId val="572058064"/>
      </c:barChart>
      <c:catAx>
        <c:axId val="1006382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2058064"/>
        <c:crosses val="autoZero"/>
        <c:auto val="1"/>
        <c:lblAlgn val="ctr"/>
        <c:lblOffset val="100"/>
        <c:noMultiLvlLbl val="0"/>
      </c:catAx>
      <c:valAx>
        <c:axId val="5720580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06382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Microsoft PowerPoint 内のグラフ]Sheet1'!$AE$3</c:f>
              <c:strCache>
                <c:ptCount val="1"/>
                <c:pt idx="0">
                  <c:v>ISR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icrosoft PowerPoint 内のグラフ]Sheet1'!$AF$7:$AQ$7</c:f>
                <c:numCache>
                  <c:formatCode>General</c:formatCode>
                  <c:ptCount val="12"/>
                  <c:pt idx="0">
                    <c:v>11.015141094572204</c:v>
                  </c:pt>
                  <c:pt idx="1">
                    <c:v>21.931712199461309</c:v>
                  </c:pt>
                  <c:pt idx="2">
                    <c:v>3.214550253664318</c:v>
                  </c:pt>
                  <c:pt idx="3">
                    <c:v>8.7368949480541058</c:v>
                  </c:pt>
                  <c:pt idx="4">
                    <c:v>13</c:v>
                  </c:pt>
                  <c:pt idx="5">
                    <c:v>8.8881944173155887</c:v>
                  </c:pt>
                  <c:pt idx="6">
                    <c:v>11.060440015358067</c:v>
                  </c:pt>
                  <c:pt idx="7">
                    <c:v>7.5718777944003746</c:v>
                  </c:pt>
                  <c:pt idx="8">
                    <c:v>5.8594652770823181</c:v>
                  </c:pt>
                  <c:pt idx="9">
                    <c:v>2.0816659994661317</c:v>
                  </c:pt>
                  <c:pt idx="10">
                    <c:v>9.1651513899116797</c:v>
                  </c:pt>
                  <c:pt idx="11">
                    <c:v>1.52752523165194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 内のグラフ]Sheet1'!$AF$2:$AQ$2</c:f>
              <c:strCache>
                <c:ptCount val="12"/>
                <c:pt idx="0">
                  <c:v>PEM</c:v>
                </c:pt>
                <c:pt idx="1">
                  <c:v>PTX</c:v>
                </c:pt>
                <c:pt idx="2">
                  <c:v>CDDP</c:v>
                </c:pt>
                <c:pt idx="3">
                  <c:v>5-FU</c:v>
                </c:pt>
                <c:pt idx="4">
                  <c:v>DOC</c:v>
                </c:pt>
                <c:pt idx="5">
                  <c:v>CBDCA</c:v>
                </c:pt>
                <c:pt idx="6">
                  <c:v>ETP</c:v>
                </c:pt>
                <c:pt idx="7">
                  <c:v>GEM</c:v>
                </c:pt>
                <c:pt idx="8">
                  <c:v>VNR</c:v>
                </c:pt>
                <c:pt idx="9">
                  <c:v>Dex</c:v>
                </c:pt>
                <c:pt idx="10">
                  <c:v>IR</c:v>
                </c:pt>
                <c:pt idx="11">
                  <c:v>NIR</c:v>
                </c:pt>
              </c:strCache>
            </c:strRef>
          </c:cat>
          <c:val>
            <c:numRef>
              <c:f>'[Microsoft PowerPoint 内のグラフ]Sheet1'!$AF$3:$AQ$3</c:f>
              <c:numCache>
                <c:formatCode>General</c:formatCode>
                <c:ptCount val="12"/>
                <c:pt idx="0">
                  <c:v>121.33333333333333</c:v>
                </c:pt>
                <c:pt idx="1">
                  <c:v>125</c:v>
                </c:pt>
                <c:pt idx="2">
                  <c:v>119.66666666666667</c:v>
                </c:pt>
                <c:pt idx="3">
                  <c:v>102.33333333333333</c:v>
                </c:pt>
                <c:pt idx="4">
                  <c:v>113</c:v>
                </c:pt>
                <c:pt idx="5">
                  <c:v>85</c:v>
                </c:pt>
                <c:pt idx="6">
                  <c:v>86.333333333333329</c:v>
                </c:pt>
                <c:pt idx="7">
                  <c:v>43.333333333333336</c:v>
                </c:pt>
                <c:pt idx="8">
                  <c:v>24.333333333333332</c:v>
                </c:pt>
                <c:pt idx="9">
                  <c:v>7.333333333333333</c:v>
                </c:pt>
                <c:pt idx="10">
                  <c:v>100</c:v>
                </c:pt>
                <c:pt idx="11">
                  <c:v>23.3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CE-4529-AFEB-46D86DC4B784}"/>
            </c:ext>
          </c:extLst>
        </c:ser>
        <c:ser>
          <c:idx val="1"/>
          <c:order val="1"/>
          <c:tx>
            <c:strRef>
              <c:f>'[Microsoft PowerPoint 内のグラフ]Sheet1'!$AE$4</c:f>
              <c:strCache>
                <c:ptCount val="1"/>
                <c:pt idx="0">
                  <c:v>Mx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icrosoft PowerPoint 内のグラフ]Sheet1'!$AF$8:$AQ$8</c:f>
                <c:numCache>
                  <c:formatCode>General</c:formatCode>
                  <c:ptCount val="12"/>
                  <c:pt idx="0">
                    <c:v>28.053520278211074</c:v>
                  </c:pt>
                  <c:pt idx="1">
                    <c:v>8.8881944173155887</c:v>
                  </c:pt>
                  <c:pt idx="2">
                    <c:v>11.532562594670797</c:v>
                  </c:pt>
                  <c:pt idx="3">
                    <c:v>6.6583281184793925</c:v>
                  </c:pt>
                  <c:pt idx="4">
                    <c:v>10.016652800877813</c:v>
                  </c:pt>
                  <c:pt idx="5">
                    <c:v>23.515952032609693</c:v>
                  </c:pt>
                  <c:pt idx="6">
                    <c:v>3</c:v>
                  </c:pt>
                  <c:pt idx="7">
                    <c:v>14.933184523068078</c:v>
                  </c:pt>
                  <c:pt idx="8">
                    <c:v>6.6583281184793872</c:v>
                  </c:pt>
                  <c:pt idx="9">
                    <c:v>3.2145502536643153</c:v>
                  </c:pt>
                  <c:pt idx="10">
                    <c:v>7.2111025509279782</c:v>
                  </c:pt>
                  <c:pt idx="11">
                    <c:v>1.52752523165194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 内のグラフ]Sheet1'!$AF$2:$AQ$2</c:f>
              <c:strCache>
                <c:ptCount val="12"/>
                <c:pt idx="0">
                  <c:v>PEM</c:v>
                </c:pt>
                <c:pt idx="1">
                  <c:v>PTX</c:v>
                </c:pt>
                <c:pt idx="2">
                  <c:v>CDDP</c:v>
                </c:pt>
                <c:pt idx="3">
                  <c:v>5-FU</c:v>
                </c:pt>
                <c:pt idx="4">
                  <c:v>DOC</c:v>
                </c:pt>
                <c:pt idx="5">
                  <c:v>CBDCA</c:v>
                </c:pt>
                <c:pt idx="6">
                  <c:v>ETP</c:v>
                </c:pt>
                <c:pt idx="7">
                  <c:v>GEM</c:v>
                </c:pt>
                <c:pt idx="8">
                  <c:v>VNR</c:v>
                </c:pt>
                <c:pt idx="9">
                  <c:v>Dex</c:v>
                </c:pt>
                <c:pt idx="10">
                  <c:v>IR</c:v>
                </c:pt>
                <c:pt idx="11">
                  <c:v>NIR</c:v>
                </c:pt>
              </c:strCache>
            </c:strRef>
          </c:cat>
          <c:val>
            <c:numRef>
              <c:f>'[Microsoft PowerPoint 内のグラフ]Sheet1'!$AF$4:$AQ$4</c:f>
              <c:numCache>
                <c:formatCode>General</c:formatCode>
                <c:ptCount val="12"/>
                <c:pt idx="0">
                  <c:v>109.66666666666667</c:v>
                </c:pt>
                <c:pt idx="1">
                  <c:v>116.66666666666667</c:v>
                </c:pt>
                <c:pt idx="2">
                  <c:v>116.66666666666667</c:v>
                </c:pt>
                <c:pt idx="3">
                  <c:v>101.33333333333333</c:v>
                </c:pt>
                <c:pt idx="4">
                  <c:v>93.666666666666671</c:v>
                </c:pt>
                <c:pt idx="5">
                  <c:v>105</c:v>
                </c:pt>
                <c:pt idx="6">
                  <c:v>53.666666666666664</c:v>
                </c:pt>
                <c:pt idx="7">
                  <c:v>49.666666666666664</c:v>
                </c:pt>
                <c:pt idx="8">
                  <c:v>25.666666666666668</c:v>
                </c:pt>
                <c:pt idx="9">
                  <c:v>3.6666666666666665</c:v>
                </c:pt>
                <c:pt idx="10">
                  <c:v>100</c:v>
                </c:pt>
                <c:pt idx="11">
                  <c:v>35.66666666666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ECE-4529-AFEB-46D86DC4B784}"/>
            </c:ext>
          </c:extLst>
        </c:ser>
        <c:ser>
          <c:idx val="2"/>
          <c:order val="2"/>
          <c:tx>
            <c:strRef>
              <c:f>'[Microsoft PowerPoint 内のグラフ]Sheet1'!$AE$5</c:f>
              <c:strCache>
                <c:ptCount val="1"/>
                <c:pt idx="0">
                  <c:v>PD-L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icrosoft PowerPoint 内のグラフ]Sheet1'!$AF$9:$AQ$9</c:f>
                <c:numCache>
                  <c:formatCode>General</c:formatCode>
                  <c:ptCount val="12"/>
                  <c:pt idx="0">
                    <c:v>15.686240703077299</c:v>
                  </c:pt>
                  <c:pt idx="1">
                    <c:v>5.7735026918962573</c:v>
                  </c:pt>
                  <c:pt idx="2">
                    <c:v>10.115993936995679</c:v>
                  </c:pt>
                  <c:pt idx="3">
                    <c:v>33.511884584284203</c:v>
                  </c:pt>
                  <c:pt idx="4">
                    <c:v>5.0332229568471663</c:v>
                  </c:pt>
                  <c:pt idx="5">
                    <c:v>4.358898943540674</c:v>
                  </c:pt>
                  <c:pt idx="6">
                    <c:v>4.7258156262526088</c:v>
                  </c:pt>
                  <c:pt idx="7">
                    <c:v>9.0737717258774744</c:v>
                  </c:pt>
                  <c:pt idx="8">
                    <c:v>4.041451884327385</c:v>
                  </c:pt>
                  <c:pt idx="9">
                    <c:v>1.5275252316519463</c:v>
                  </c:pt>
                  <c:pt idx="10">
                    <c:v>26</c:v>
                  </c:pt>
                  <c:pt idx="11">
                    <c:v>8.14452781524707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 内のグラフ]Sheet1'!$AF$2:$AQ$2</c:f>
              <c:strCache>
                <c:ptCount val="12"/>
                <c:pt idx="0">
                  <c:v>PEM</c:v>
                </c:pt>
                <c:pt idx="1">
                  <c:v>PTX</c:v>
                </c:pt>
                <c:pt idx="2">
                  <c:v>CDDP</c:v>
                </c:pt>
                <c:pt idx="3">
                  <c:v>5-FU</c:v>
                </c:pt>
                <c:pt idx="4">
                  <c:v>DOC</c:v>
                </c:pt>
                <c:pt idx="5">
                  <c:v>CBDCA</c:v>
                </c:pt>
                <c:pt idx="6">
                  <c:v>ETP</c:v>
                </c:pt>
                <c:pt idx="7">
                  <c:v>GEM</c:v>
                </c:pt>
                <c:pt idx="8">
                  <c:v>VNR</c:v>
                </c:pt>
                <c:pt idx="9">
                  <c:v>Dex</c:v>
                </c:pt>
                <c:pt idx="10">
                  <c:v>IR</c:v>
                </c:pt>
                <c:pt idx="11">
                  <c:v>NIR</c:v>
                </c:pt>
              </c:strCache>
            </c:strRef>
          </c:cat>
          <c:val>
            <c:numRef>
              <c:f>'[Microsoft PowerPoint 内のグラフ]Sheet1'!$AF$5:$AQ$5</c:f>
              <c:numCache>
                <c:formatCode>General</c:formatCode>
                <c:ptCount val="12"/>
                <c:pt idx="0">
                  <c:v>132</c:v>
                </c:pt>
                <c:pt idx="1">
                  <c:v>125</c:v>
                </c:pt>
                <c:pt idx="2">
                  <c:v>113</c:v>
                </c:pt>
                <c:pt idx="3">
                  <c:v>102.33333333333333</c:v>
                </c:pt>
                <c:pt idx="4">
                  <c:v>132.33333333333334</c:v>
                </c:pt>
                <c:pt idx="5">
                  <c:v>93</c:v>
                </c:pt>
                <c:pt idx="6">
                  <c:v>68</c:v>
                </c:pt>
                <c:pt idx="7">
                  <c:v>109</c:v>
                </c:pt>
                <c:pt idx="8">
                  <c:v>26.666666666666668</c:v>
                </c:pt>
                <c:pt idx="9">
                  <c:v>16.666666666666668</c:v>
                </c:pt>
                <c:pt idx="10">
                  <c:v>100</c:v>
                </c:pt>
                <c:pt idx="11">
                  <c:v>30.66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ECE-4529-AFEB-46D86DC4B784}"/>
            </c:ext>
          </c:extLst>
        </c:ser>
        <c:ser>
          <c:idx val="3"/>
          <c:order val="3"/>
          <c:tx>
            <c:strRef>
              <c:f>'[Microsoft PowerPoint 内のグラフ]Sheet1'!$AE$6</c:f>
              <c:strCache>
                <c:ptCount val="1"/>
                <c:pt idx="0">
                  <c:v>HLA-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icrosoft PowerPoint 内のグラフ]Sheet1'!$AF$10:$AQ$10</c:f>
                <c:numCache>
                  <c:formatCode>General</c:formatCode>
                  <c:ptCount val="12"/>
                  <c:pt idx="0">
                    <c:v>25.686240703077299</c:v>
                  </c:pt>
                  <c:pt idx="1">
                    <c:v>15.7735026918962</c:v>
                  </c:pt>
                  <c:pt idx="2">
                    <c:v>10.115993936995679</c:v>
                  </c:pt>
                  <c:pt idx="3">
                    <c:v>33.511884584284203</c:v>
                  </c:pt>
                  <c:pt idx="4">
                    <c:v>25.033222956847101</c:v>
                  </c:pt>
                  <c:pt idx="5">
                    <c:v>4.358898943540674</c:v>
                  </c:pt>
                  <c:pt idx="6">
                    <c:v>34.725815626252597</c:v>
                  </c:pt>
                  <c:pt idx="7">
                    <c:v>19.0737717258774</c:v>
                  </c:pt>
                  <c:pt idx="8">
                    <c:v>24.041451884327302</c:v>
                  </c:pt>
                  <c:pt idx="9">
                    <c:v>11.5275252316519</c:v>
                  </c:pt>
                  <c:pt idx="10">
                    <c:v>26</c:v>
                  </c:pt>
                  <c:pt idx="11">
                    <c:v>28.144527815246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 内のグラフ]Sheet1'!$AF$2:$AQ$2</c:f>
              <c:strCache>
                <c:ptCount val="12"/>
                <c:pt idx="0">
                  <c:v>PEM</c:v>
                </c:pt>
                <c:pt idx="1">
                  <c:v>PTX</c:v>
                </c:pt>
                <c:pt idx="2">
                  <c:v>CDDP</c:v>
                </c:pt>
                <c:pt idx="3">
                  <c:v>5-FU</c:v>
                </c:pt>
                <c:pt idx="4">
                  <c:v>DOC</c:v>
                </c:pt>
                <c:pt idx="5">
                  <c:v>CBDCA</c:v>
                </c:pt>
                <c:pt idx="6">
                  <c:v>ETP</c:v>
                </c:pt>
                <c:pt idx="7">
                  <c:v>GEM</c:v>
                </c:pt>
                <c:pt idx="8">
                  <c:v>VNR</c:v>
                </c:pt>
                <c:pt idx="9">
                  <c:v>Dex</c:v>
                </c:pt>
                <c:pt idx="10">
                  <c:v>IR</c:v>
                </c:pt>
                <c:pt idx="11">
                  <c:v>NIR</c:v>
                </c:pt>
              </c:strCache>
            </c:strRef>
          </c:cat>
          <c:val>
            <c:numRef>
              <c:f>'[Microsoft PowerPoint 内のグラフ]Sheet1'!$AF$6:$AQ$6</c:f>
              <c:numCache>
                <c:formatCode>General</c:formatCode>
                <c:ptCount val="12"/>
                <c:pt idx="0">
                  <c:v>122.92192494087972</c:v>
                </c:pt>
                <c:pt idx="1">
                  <c:v>146.15232196766101</c:v>
                </c:pt>
                <c:pt idx="2">
                  <c:v>98.072421287899999</c:v>
                </c:pt>
                <c:pt idx="3">
                  <c:v>104.05381409978652</c:v>
                </c:pt>
                <c:pt idx="4">
                  <c:v>136.861281261448</c:v>
                </c:pt>
                <c:pt idx="5">
                  <c:v>98.677446939908506</c:v>
                </c:pt>
                <c:pt idx="6">
                  <c:v>104.640925279215</c:v>
                </c:pt>
                <c:pt idx="7">
                  <c:v>38.082023416089001</c:v>
                </c:pt>
                <c:pt idx="8">
                  <c:v>28.90309953550215</c:v>
                </c:pt>
                <c:pt idx="9">
                  <c:v>4.3382181290143764</c:v>
                </c:pt>
                <c:pt idx="10">
                  <c:v>100</c:v>
                </c:pt>
                <c:pt idx="11">
                  <c:v>29.8888888888888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ECE-4529-AFEB-46D86DC4B7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9322168"/>
        <c:axId val="829325448"/>
      </c:barChart>
      <c:catAx>
        <c:axId val="829322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29325448"/>
        <c:crosses val="autoZero"/>
        <c:auto val="1"/>
        <c:lblAlgn val="ctr"/>
        <c:lblOffset val="100"/>
        <c:noMultiLvlLbl val="0"/>
      </c:catAx>
      <c:valAx>
        <c:axId val="829325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29322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R$77</c:f>
              <c:strCache>
                <c:ptCount val="1"/>
                <c:pt idx="0">
                  <c:v>ISR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S$76:$AB$76</c:f>
              <c:strCache>
                <c:ptCount val="10"/>
                <c:pt idx="0">
                  <c:v>PEM</c:v>
                </c:pt>
                <c:pt idx="1">
                  <c:v>PTX</c:v>
                </c:pt>
                <c:pt idx="2">
                  <c:v>CDDP</c:v>
                </c:pt>
                <c:pt idx="3">
                  <c:v>5-FU</c:v>
                </c:pt>
                <c:pt idx="4">
                  <c:v>DOC</c:v>
                </c:pt>
                <c:pt idx="5">
                  <c:v>CBDCA</c:v>
                </c:pt>
                <c:pt idx="6">
                  <c:v>ETP</c:v>
                </c:pt>
                <c:pt idx="7">
                  <c:v>VNR</c:v>
                </c:pt>
                <c:pt idx="8">
                  <c:v>Dex</c:v>
                </c:pt>
                <c:pt idx="9">
                  <c:v>IR</c:v>
                </c:pt>
              </c:strCache>
            </c:strRef>
          </c:cat>
          <c:val>
            <c:numRef>
              <c:f>Sheet1!$S$77:$AB$77</c:f>
              <c:numCache>
                <c:formatCode>General</c:formatCode>
                <c:ptCount val="10"/>
                <c:pt idx="0">
                  <c:v>138.83806969770879</c:v>
                </c:pt>
                <c:pt idx="1">
                  <c:v>135.46794759030587</c:v>
                </c:pt>
                <c:pt idx="2">
                  <c:v>128.25835453122286</c:v>
                </c:pt>
                <c:pt idx="3">
                  <c:v>110.41646435978194</c:v>
                </c:pt>
                <c:pt idx="4">
                  <c:v>84.024910179134309</c:v>
                </c:pt>
                <c:pt idx="5">
                  <c:v>82.015212307654224</c:v>
                </c:pt>
                <c:pt idx="6">
                  <c:v>78.734155207781896</c:v>
                </c:pt>
                <c:pt idx="7">
                  <c:v>29.68256482682456</c:v>
                </c:pt>
                <c:pt idx="8">
                  <c:v>7.2719165175233886</c:v>
                </c:pt>
                <c:pt idx="9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9D-4820-AB95-1E08ABE3A3EA}"/>
            </c:ext>
          </c:extLst>
        </c:ser>
        <c:ser>
          <c:idx val="1"/>
          <c:order val="1"/>
          <c:tx>
            <c:strRef>
              <c:f>Sheet1!$R$78</c:f>
              <c:strCache>
                <c:ptCount val="1"/>
                <c:pt idx="0">
                  <c:v>HLA-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S$76:$AB$76</c:f>
              <c:strCache>
                <c:ptCount val="10"/>
                <c:pt idx="0">
                  <c:v>PEM</c:v>
                </c:pt>
                <c:pt idx="1">
                  <c:v>PTX</c:v>
                </c:pt>
                <c:pt idx="2">
                  <c:v>CDDP</c:v>
                </c:pt>
                <c:pt idx="3">
                  <c:v>5-FU</c:v>
                </c:pt>
                <c:pt idx="4">
                  <c:v>DOC</c:v>
                </c:pt>
                <c:pt idx="5">
                  <c:v>CBDCA</c:v>
                </c:pt>
                <c:pt idx="6">
                  <c:v>ETP</c:v>
                </c:pt>
                <c:pt idx="7">
                  <c:v>VNR</c:v>
                </c:pt>
                <c:pt idx="8">
                  <c:v>Dex</c:v>
                </c:pt>
                <c:pt idx="9">
                  <c:v>IR</c:v>
                </c:pt>
              </c:strCache>
            </c:strRef>
          </c:cat>
          <c:val>
            <c:numRef>
              <c:f>Sheet1!$S$78:$AB$78</c:f>
              <c:numCache>
                <c:formatCode>General</c:formatCode>
                <c:ptCount val="10"/>
                <c:pt idx="0">
                  <c:v>107.19626097429797</c:v>
                </c:pt>
                <c:pt idx="1">
                  <c:v>103.87386090763788</c:v>
                </c:pt>
                <c:pt idx="2">
                  <c:v>106.98794815662094</c:v>
                </c:pt>
                <c:pt idx="3">
                  <c:v>99.550801814972772</c:v>
                </c:pt>
                <c:pt idx="4">
                  <c:v>95.783748570216559</c:v>
                </c:pt>
                <c:pt idx="5">
                  <c:v>107.04854824903607</c:v>
                </c:pt>
                <c:pt idx="6">
                  <c:v>78.413489580571607</c:v>
                </c:pt>
                <c:pt idx="7">
                  <c:v>39.736238097763099</c:v>
                </c:pt>
                <c:pt idx="8">
                  <c:v>15.809806609955078</c:v>
                </c:pt>
                <c:pt idx="9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9D-4820-AB95-1E08ABE3A3EA}"/>
            </c:ext>
          </c:extLst>
        </c:ser>
        <c:ser>
          <c:idx val="2"/>
          <c:order val="2"/>
          <c:tx>
            <c:strRef>
              <c:f>Sheet1!$R$79</c:f>
              <c:strCache>
                <c:ptCount val="1"/>
                <c:pt idx="0">
                  <c:v>HLA-B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S$76:$AB$76</c:f>
              <c:strCache>
                <c:ptCount val="10"/>
                <c:pt idx="0">
                  <c:v>PEM</c:v>
                </c:pt>
                <c:pt idx="1">
                  <c:v>PTX</c:v>
                </c:pt>
                <c:pt idx="2">
                  <c:v>CDDP</c:v>
                </c:pt>
                <c:pt idx="3">
                  <c:v>5-FU</c:v>
                </c:pt>
                <c:pt idx="4">
                  <c:v>DOC</c:v>
                </c:pt>
                <c:pt idx="5">
                  <c:v>CBDCA</c:v>
                </c:pt>
                <c:pt idx="6">
                  <c:v>ETP</c:v>
                </c:pt>
                <c:pt idx="7">
                  <c:v>VNR</c:v>
                </c:pt>
                <c:pt idx="8">
                  <c:v>Dex</c:v>
                </c:pt>
                <c:pt idx="9">
                  <c:v>IR</c:v>
                </c:pt>
              </c:strCache>
            </c:strRef>
          </c:cat>
          <c:val>
            <c:numRef>
              <c:f>Sheet1!$S$79:$AB$79</c:f>
              <c:numCache>
                <c:formatCode>General</c:formatCode>
                <c:ptCount val="10"/>
                <c:pt idx="0">
                  <c:v>141.73692640768837</c:v>
                </c:pt>
                <c:pt idx="1">
                  <c:v>122.57933923573829</c:v>
                </c:pt>
                <c:pt idx="2">
                  <c:v>105.11502649041593</c:v>
                </c:pt>
                <c:pt idx="3">
                  <c:v>100.41363772376042</c:v>
                </c:pt>
                <c:pt idx="4">
                  <c:v>112.92133842606444</c:v>
                </c:pt>
                <c:pt idx="5">
                  <c:v>106.14120007744705</c:v>
                </c:pt>
                <c:pt idx="6">
                  <c:v>57.212257757907523</c:v>
                </c:pt>
                <c:pt idx="7">
                  <c:v>30.563427384577473</c:v>
                </c:pt>
                <c:pt idx="8">
                  <c:v>1.8094450213859505</c:v>
                </c:pt>
                <c:pt idx="9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B9D-4820-AB95-1E08ABE3A3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8828240"/>
        <c:axId val="348829360"/>
      </c:barChart>
      <c:catAx>
        <c:axId val="348828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48829360"/>
        <c:crosses val="autoZero"/>
        <c:auto val="1"/>
        <c:lblAlgn val="ctr"/>
        <c:lblOffset val="100"/>
        <c:noMultiLvlLbl val="0"/>
      </c:catAx>
      <c:valAx>
        <c:axId val="3488293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488282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ISRE activity</a:t>
            </a:r>
            <a:endParaRPr lang="ja-JP"/>
          </a:p>
        </c:rich>
      </c:tx>
      <c:layout>
        <c:manualLayout>
          <c:xMode val="edge"/>
          <c:yMode val="edge"/>
          <c:x val="0.42404475634700933"/>
          <c:y val="3.793222576543946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plate25!$A$113:$A$118</c:f>
              <c:strCache>
                <c:ptCount val="6"/>
                <c:pt idx="0">
                  <c:v>CDK1/2i (BMS-265246)</c:v>
                </c:pt>
                <c:pt idx="1">
                  <c:v>Aur Ai (Alisertib)</c:v>
                </c:pt>
                <c:pt idx="2">
                  <c:v>Microtubule polyi (VNR)</c:v>
                </c:pt>
                <c:pt idx="3">
                  <c:v>Aur Bi (Tozasertib)</c:v>
                </c:pt>
                <c:pt idx="4">
                  <c:v>Microtubule depolyi (DOC)</c:v>
                </c:pt>
                <c:pt idx="5">
                  <c:v>IR alone</c:v>
                </c:pt>
              </c:strCache>
            </c:strRef>
          </c:cat>
          <c:val>
            <c:numRef>
              <c:f>plate25!$B$113:$B$118</c:f>
              <c:numCache>
                <c:formatCode>0.00_);[Red]\(0.00\)</c:formatCode>
                <c:ptCount val="6"/>
                <c:pt idx="0">
                  <c:v>21.753000080804934</c:v>
                </c:pt>
                <c:pt idx="1">
                  <c:v>25.976626150624156</c:v>
                </c:pt>
                <c:pt idx="2">
                  <c:v>27.802685199065664</c:v>
                </c:pt>
                <c:pt idx="3">
                  <c:v>95.137821369051352</c:v>
                </c:pt>
                <c:pt idx="4">
                  <c:v>120.06131262214468</c:v>
                </c:pt>
                <c:pt idx="5" formatCode="General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24-4202-BAEE-0BA35A7D2D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3374816"/>
        <c:axId val="683378176"/>
      </c:barChart>
      <c:catAx>
        <c:axId val="683374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83378176"/>
        <c:crosses val="autoZero"/>
        <c:auto val="1"/>
        <c:lblAlgn val="ctr"/>
        <c:lblOffset val="100"/>
        <c:noMultiLvlLbl val="0"/>
      </c:catAx>
      <c:valAx>
        <c:axId val="683378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833748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ISRE activity</a:t>
            </a:r>
            <a:endParaRPr lang="ja-JP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plate25!$A$82:$A$90</c:f>
              <c:strCache>
                <c:ptCount val="9"/>
                <c:pt idx="0">
                  <c:v>Osimertinib </c:v>
                </c:pt>
                <c:pt idx="1">
                  <c:v>Entrectinib </c:v>
                </c:pt>
                <c:pt idx="2">
                  <c:v>Olaparib </c:v>
                </c:pt>
                <c:pt idx="3">
                  <c:v>Crizotinib</c:v>
                </c:pt>
                <c:pt idx="4">
                  <c:v>Dabrafenib</c:v>
                </c:pt>
                <c:pt idx="5">
                  <c:v>Trametinib</c:v>
                </c:pt>
                <c:pt idx="6">
                  <c:v>Vorinostat </c:v>
                </c:pt>
                <c:pt idx="8">
                  <c:v>IR alone</c:v>
                </c:pt>
              </c:strCache>
            </c:strRef>
          </c:cat>
          <c:val>
            <c:numRef>
              <c:f>plate25!$B$82:$B$90</c:f>
              <c:numCache>
                <c:formatCode>General</c:formatCode>
                <c:ptCount val="9"/>
                <c:pt idx="0">
                  <c:v>167.4954930137358</c:v>
                </c:pt>
                <c:pt idx="1">
                  <c:v>138</c:v>
                </c:pt>
                <c:pt idx="2">
                  <c:v>110.06861784531728</c:v>
                </c:pt>
                <c:pt idx="3">
                  <c:v>92.9020753541961</c:v>
                </c:pt>
                <c:pt idx="4">
                  <c:v>21.404736166924167</c:v>
                </c:pt>
                <c:pt idx="5">
                  <c:v>12.279697249101602</c:v>
                </c:pt>
                <c:pt idx="6">
                  <c:v>10.521801589265637</c:v>
                </c:pt>
                <c:pt idx="8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71-4C18-AA45-EB033F1B30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27855856"/>
        <c:axId val="944232272"/>
      </c:barChart>
      <c:catAx>
        <c:axId val="1027855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44232272"/>
        <c:crosses val="autoZero"/>
        <c:auto val="1"/>
        <c:lblAlgn val="ctr"/>
        <c:lblOffset val="100"/>
        <c:noMultiLvlLbl val="0"/>
      </c:catAx>
      <c:valAx>
        <c:axId val="944232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7855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ISRE activit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late25!$B$101</c:f>
              <c:strCache>
                <c:ptCount val="1"/>
                <c:pt idx="0">
                  <c:v>ISRE activit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plate25!$A$102:$A$110</c:f>
              <c:strCache>
                <c:ptCount val="9"/>
                <c:pt idx="0">
                  <c:v>Celecoxib</c:v>
                </c:pt>
                <c:pt idx="1">
                  <c:v>Loxoprofen</c:v>
                </c:pt>
                <c:pt idx="2">
                  <c:v>Betamethasone </c:v>
                </c:pt>
                <c:pt idx="3">
                  <c:v>Hydrocortisone </c:v>
                </c:pt>
                <c:pt idx="4">
                  <c:v>Peficitinib </c:v>
                </c:pt>
                <c:pt idx="5">
                  <c:v>Methotrexate</c:v>
                </c:pt>
                <c:pt idx="6">
                  <c:v>Mycophenolate Mofetil</c:v>
                </c:pt>
                <c:pt idx="7">
                  <c:v>Colchicine</c:v>
                </c:pt>
                <c:pt idx="8">
                  <c:v>IR alone</c:v>
                </c:pt>
              </c:strCache>
            </c:strRef>
          </c:cat>
          <c:val>
            <c:numRef>
              <c:f>plate25!$B$102:$B$110</c:f>
              <c:numCache>
                <c:formatCode>General</c:formatCode>
                <c:ptCount val="9"/>
                <c:pt idx="0">
                  <c:v>88.730614423458945</c:v>
                </c:pt>
                <c:pt idx="1">
                  <c:v>116.01520406752606</c:v>
                </c:pt>
                <c:pt idx="2">
                  <c:v>6.4150849385713169</c:v>
                </c:pt>
                <c:pt idx="3">
                  <c:v>7.099731743589123</c:v>
                </c:pt>
                <c:pt idx="4">
                  <c:v>6.2917051154497434</c:v>
                </c:pt>
                <c:pt idx="5">
                  <c:v>12.10376343366611</c:v>
                </c:pt>
                <c:pt idx="6">
                  <c:v>5.3658303935922751</c:v>
                </c:pt>
                <c:pt idx="7">
                  <c:v>8.1530851593373939</c:v>
                </c:pt>
                <c:pt idx="8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D8-4C48-B1A7-8D188B414C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485312"/>
        <c:axId val="360486992"/>
      </c:barChart>
      <c:catAx>
        <c:axId val="360485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60486992"/>
        <c:crosses val="autoZero"/>
        <c:auto val="1"/>
        <c:lblAlgn val="ctr"/>
        <c:lblOffset val="100"/>
        <c:noMultiLvlLbl val="0"/>
      </c:catAx>
      <c:valAx>
        <c:axId val="360486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60485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1492</cdr:x>
      <cdr:y>0.39479</cdr:y>
    </cdr:from>
    <cdr:to>
      <cdr:x>0.58508</cdr:x>
      <cdr:y>0.60521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F57D666A-E507-4547-BB0B-A359D54572D6}"/>
            </a:ext>
          </a:extLst>
        </cdr:cNvPr>
        <cdr:cNvSpPr txBox="1"/>
      </cdr:nvSpPr>
      <cdr:spPr>
        <a:xfrm xmlns:a="http://schemas.openxmlformats.org/drawingml/2006/main">
          <a:off x="2229595" y="1715549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8E43BF-3094-4DB4-9D5B-12E3F6D5E096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16CE0C-25E5-4286-B2F2-DF12710399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8854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93CC3F7E-70FE-4B69-81BE-3A765F0626D0}" type="slidenum">
              <a:rPr lang="ja-JP" altLang="en-US" smtClean="0"/>
              <a:pPr>
                <a:defRPr/>
              </a:pPr>
              <a:t>4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049848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1B2EB5-BCA8-4BDE-8DBF-3535E3F6DD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4D3BAC9-8397-4145-88A5-8EC03C91B7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E0FDD1-61B5-4DDB-8F27-60E38D627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9C0152-6042-4D0A-9EE1-2B665A878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6CAB74-0F27-4675-A30C-4DC23A549B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9943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518BC7-7138-4984-AE5C-38F5D91C24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F2CE5CC-2696-4FC3-9D75-63604A06A9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08037F-C1CD-4247-BFE0-EFE81F466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E071C2-FB65-4C8E-8E99-F95A008C3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85F9AF-1E4F-4708-B300-1C09CBDF2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360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95B284F-A21A-4B88-A187-CB5973944F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6A62CA4-7D7D-4BD6-9EFD-408D20B244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A2BBA4-9E0B-4930-8137-31BB58267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462C47-E513-4A04-8755-6D9301313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D3844C6-7260-4BAD-9FDD-A382F56F6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73843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4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038AD6-CB02-4CEB-9104-A19A8C285F18}" type="slidenum">
              <a:rPr/>
              <a:pPr>
                <a:defRPr/>
              </a:pPr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815704260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CF5F4D-D60C-4FEC-89B0-C9F7F7A2B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384809A-1D67-4C62-AC01-15B121297A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144497-A2E1-45A9-87AC-C7B228244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2FD9D92-7A65-4A6F-B222-4059A3913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F9243F-7FA6-4254-9C21-C86B7366A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093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CAF5D2-1509-45C5-8B86-E6A55011D6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F907E0F-6752-4A11-A2EB-A19700D4B2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34973C2-8C69-4CAC-B6C5-778FFA782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B277AC-C5BD-422C-82F4-11D740229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B0ED2B-1045-4734-8A3B-570054552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0844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465745-2CA9-4C4D-95C6-1DE057222C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4C5AF89-6B25-4EAE-A20C-0990EE95AD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35C1D4A-A5CB-4182-BE17-8C24EE2AFA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F1E00B4-BED7-4879-8139-E5AF95605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C99A51A-BC36-4941-BE75-E62837ECCE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E3EA93F-522C-4A0C-841D-C6F3B2C26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195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9AF79B-6CA8-4189-8B95-671A2A961E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B38EBA-E9C1-4C95-AA0D-17CFF0CC15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FBF33EE-15E8-4E14-9FE6-FC7D3F6628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4AC80E7-9127-4E43-9573-8CF44E6C99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5992F55-F273-46DD-92FC-316E816B1C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48F580A-7954-46EA-B72E-E5B009489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E02AAB0-3D37-419A-92E6-C984FF1B4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E97C987-731F-4F36-835E-35DEB79A2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5711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431A6E-6E74-41D6-B268-85D33C24B1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7CCC8CF-3418-4605-AD02-5F1713763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B113034-7CD8-4CFC-88BE-AE43C69D8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88306F2-E4BE-4A75-B28B-341ED2A32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775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E7C40A7-ECCD-4B27-8260-9E9199C16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218B833-9D96-4A07-9100-24711A183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85B8D1E-09F6-41B8-B63A-9480BFA6E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585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34B5F8-B9FF-4793-83A9-4C3D80231B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785780-F6E2-4CBA-BEFE-8A7526FFC1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56BDB61-1975-4792-83DC-773C9E9D0D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064541D-34C1-47CC-BD10-0596AAB276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650F213-0494-438A-BF54-05B7C4FF5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CFBC357-5D72-43F5-9586-2A0C1D39A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21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75C6DB-3231-4DB4-B1D1-7776FA676E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E3E7A53-37F9-41EB-9DF9-F5D61097DB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A1C8075-F336-4D99-B704-953E13322B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892BBA-3E08-4EC2-9D01-2EA6EC7A6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C8E4974-02EF-430B-8A56-024AB3A7C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D856739-8D41-4B30-916F-641CF2501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699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3AC9719-52D9-46FA-9E09-786184E95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8535005-02A9-4EF7-B591-91D52F922F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3C9DCA1-8288-418D-8126-95C1C54A02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7ACE0-AD3B-4840-A06C-09F44524FC3D}" type="datetimeFigureOut">
              <a:rPr kumimoji="1" lang="ja-JP" altLang="en-US" smtClean="0"/>
              <a:t>2021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EB2CDB-58B4-4A44-AA69-1570CF555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7F08C0-A7BE-4E63-A652-C9C3115AD3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40912-EF7B-4EBE-A875-11E24A21B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2986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7E22CAC2-C121-43BD-885F-B4EBD4329B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2896252"/>
              </p:ext>
            </p:extLst>
          </p:nvPr>
        </p:nvGraphicFramePr>
        <p:xfrm>
          <a:off x="6253549" y="1442906"/>
          <a:ext cx="5373591" cy="43454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9B7F4736-5027-4B66-8FE9-D746690B0A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0500028"/>
              </p:ext>
            </p:extLst>
          </p:nvPr>
        </p:nvGraphicFramePr>
        <p:xfrm>
          <a:off x="654341" y="1501629"/>
          <a:ext cx="5284110" cy="43454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D5754DF-A702-439B-9E23-F9FE7B2A7ED2}"/>
              </a:ext>
            </a:extLst>
          </p:cNvPr>
          <p:cNvSpPr txBox="1"/>
          <p:nvPr/>
        </p:nvSpPr>
        <p:spPr>
          <a:xfrm>
            <a:off x="788927" y="377140"/>
            <a:ext cx="10944737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GA in STING knockout cells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BEB67EE-75B7-46E5-94DF-1A4196F055E5}"/>
              </a:ext>
            </a:extLst>
          </p:cNvPr>
          <p:cNvSpPr txBox="1"/>
          <p:nvPr/>
        </p:nvSpPr>
        <p:spPr>
          <a:xfrm>
            <a:off x="5201043" y="1758866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60">
            <a:extLst>
              <a:ext uri="{FF2B5EF4-FFF2-40B4-BE49-F238E27FC236}">
                <a16:creationId xmlns:a16="http://schemas.microsoft.com/office/drawing/2014/main" id="{7E22AEC3-CD8D-406C-A5A4-D4E7996C1D3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482327" y="3598768"/>
            <a:ext cx="180197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algn="ctr" eaLnBrk="1" hangingPunct="1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value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4F4A9AD-CBAB-4F40-8B80-2109241FD36F}"/>
              </a:ext>
            </a:extLst>
          </p:cNvPr>
          <p:cNvSpPr txBox="1"/>
          <p:nvPr/>
        </p:nvSpPr>
        <p:spPr>
          <a:xfrm>
            <a:off x="10744888" y="1758866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60">
            <a:extLst>
              <a:ext uri="{FF2B5EF4-FFF2-40B4-BE49-F238E27FC236}">
                <a16:creationId xmlns:a16="http://schemas.microsoft.com/office/drawing/2014/main" id="{98B09CE5-E511-4005-80EA-C81B7950CA1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352562" y="3598768"/>
            <a:ext cx="180197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algn="ctr" eaLnBrk="1" hangingPunct="1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value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DF1F3F2-F918-45E3-8221-1972C374FB71}"/>
              </a:ext>
            </a:extLst>
          </p:cNvPr>
          <p:cNvSpPr txBox="1"/>
          <p:nvPr/>
        </p:nvSpPr>
        <p:spPr>
          <a:xfrm>
            <a:off x="8842400" y="5384950"/>
            <a:ext cx="108234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INGKO</a:t>
            </a:r>
            <a:endParaRPr kumimoji="1" lang="ja-JP" altLang="en-US" sz="1600">
              <a:solidFill>
                <a:schemeClr val="tx1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93703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A8C27802-986F-46F9-B90B-723CFED9491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8497375"/>
              </p:ext>
            </p:extLst>
          </p:nvPr>
        </p:nvGraphicFramePr>
        <p:xfrm>
          <a:off x="734366" y="1674306"/>
          <a:ext cx="10944737" cy="44740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0537D32-835C-4F6C-9920-C562280CB8BF}"/>
              </a:ext>
            </a:extLst>
          </p:cNvPr>
          <p:cNvSpPr txBox="1"/>
          <p:nvPr/>
        </p:nvSpPr>
        <p:spPr>
          <a:xfrm>
            <a:off x="932278" y="106741"/>
            <a:ext cx="10944737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arison of RGA and mRNA expression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75945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36CDF3A6-6DD2-4162-9D2D-6D2F643118EE}"/>
              </a:ext>
            </a:extLst>
          </p:cNvPr>
          <p:cNvSpPr/>
          <p:nvPr/>
        </p:nvSpPr>
        <p:spPr>
          <a:xfrm>
            <a:off x="288463" y="1450912"/>
            <a:ext cx="11615074" cy="48061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98F15136-74A2-483A-BF6B-497F98F95700}"/>
              </a:ext>
            </a:extLst>
          </p:cNvPr>
          <p:cNvGraphicFramePr>
            <a:graphicFrameLocks/>
          </p:cNvGraphicFramePr>
          <p:nvPr/>
        </p:nvGraphicFramePr>
        <p:xfrm>
          <a:off x="627018" y="1635578"/>
          <a:ext cx="10881360" cy="4621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B4573C4-338D-4EE3-8E2F-37BB28A036A5}"/>
              </a:ext>
            </a:extLst>
          </p:cNvPr>
          <p:cNvSpPr txBox="1"/>
          <p:nvPr/>
        </p:nvSpPr>
        <p:spPr>
          <a:xfrm>
            <a:off x="971607" y="254225"/>
            <a:ext cx="10944737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ja-JP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B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arison of RGA and mRNA expression in MHC class I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60">
            <a:extLst>
              <a:ext uri="{FF2B5EF4-FFF2-40B4-BE49-F238E27FC236}">
                <a16:creationId xmlns:a16="http://schemas.microsoft.com/office/drawing/2014/main" id="{170ADC60-3A09-40AB-B1F4-3ABF04D41FC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443246" y="3353793"/>
            <a:ext cx="180197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algn="ctr" eaLnBrk="1" hangingPunct="1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value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E5232EE-F487-4664-8CD1-7020D1B2F9EE}"/>
              </a:ext>
            </a:extLst>
          </p:cNvPr>
          <p:cNvSpPr txBox="1"/>
          <p:nvPr/>
        </p:nvSpPr>
        <p:spPr>
          <a:xfrm>
            <a:off x="10911740" y="1450912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7607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1EA366D1-1FF5-41BA-9F63-64F5BBEB258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-3004" r="3004"/>
          <a:stretch/>
        </p:blipFill>
        <p:spPr>
          <a:xfrm>
            <a:off x="8791508" y="4273564"/>
            <a:ext cx="2590867" cy="2267009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E9DBC84-8E74-4CE8-801D-D915842A9DFE}"/>
              </a:ext>
            </a:extLst>
          </p:cNvPr>
          <p:cNvSpPr txBox="1"/>
          <p:nvPr/>
        </p:nvSpPr>
        <p:spPr>
          <a:xfrm>
            <a:off x="6314283" y="3756952"/>
            <a:ext cx="1844367" cy="318924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 with VNR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AACBCD7-A20D-474C-A0D2-D428FD82A7BA}"/>
              </a:ext>
            </a:extLst>
          </p:cNvPr>
          <p:cNvSpPr txBox="1"/>
          <p:nvPr/>
        </p:nvSpPr>
        <p:spPr>
          <a:xfrm>
            <a:off x="6523979" y="6512152"/>
            <a:ext cx="1701819" cy="318924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X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矢印: 下 32">
            <a:extLst>
              <a:ext uri="{FF2B5EF4-FFF2-40B4-BE49-F238E27FC236}">
                <a16:creationId xmlns:a16="http://schemas.microsoft.com/office/drawing/2014/main" id="{3354FF19-10C3-457A-BEE6-01DEFE8D75AD}"/>
              </a:ext>
            </a:extLst>
          </p:cNvPr>
          <p:cNvSpPr/>
          <p:nvPr/>
        </p:nvSpPr>
        <p:spPr>
          <a:xfrm rot="2427777">
            <a:off x="10991267" y="5230077"/>
            <a:ext cx="114130" cy="241533"/>
          </a:xfrm>
          <a:prstGeom prst="downArrow">
            <a:avLst>
              <a:gd name="adj1" fmla="val 50000"/>
              <a:gd name="adj2" fmla="val 50128"/>
            </a:avLst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矢印: 下 35">
            <a:extLst>
              <a:ext uri="{FF2B5EF4-FFF2-40B4-BE49-F238E27FC236}">
                <a16:creationId xmlns:a16="http://schemas.microsoft.com/office/drawing/2014/main" id="{5654CA81-4C3D-48F4-A36C-996BBB5A1F4D}"/>
              </a:ext>
            </a:extLst>
          </p:cNvPr>
          <p:cNvSpPr/>
          <p:nvPr/>
        </p:nvSpPr>
        <p:spPr>
          <a:xfrm rot="2427777">
            <a:off x="9979767" y="5284100"/>
            <a:ext cx="114130" cy="241533"/>
          </a:xfrm>
          <a:prstGeom prst="downArrow">
            <a:avLst>
              <a:gd name="adj1" fmla="val 50000"/>
              <a:gd name="adj2" fmla="val 50128"/>
            </a:avLst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タイトル 1">
            <a:extLst>
              <a:ext uri="{FF2B5EF4-FFF2-40B4-BE49-F238E27FC236}">
                <a16:creationId xmlns:a16="http://schemas.microsoft.com/office/drawing/2014/main" id="{DD02E0C2-5DC9-4337-B76E-3893AC07D2FB}"/>
              </a:ext>
            </a:extLst>
          </p:cNvPr>
          <p:cNvSpPr txBox="1">
            <a:spLocks/>
          </p:cNvSpPr>
          <p:nvPr/>
        </p:nvSpPr>
        <p:spPr bwMode="auto">
          <a:xfrm>
            <a:off x="1521270" y="1410960"/>
            <a:ext cx="9149458" cy="11533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游ゴシック Light" panose="020B0300000000000000" pitchFamily="50" charset="-128"/>
                <a:ea typeface="游ゴシック Light" panose="020B0300000000000000" pitchFamily="50" charset="-128"/>
              </a:defRPr>
            </a:lvl2pPr>
            <a:lvl3pPr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游ゴシック Light" panose="020B0300000000000000" pitchFamily="50" charset="-128"/>
                <a:ea typeface="游ゴシック Light" panose="020B0300000000000000" pitchFamily="50" charset="-128"/>
              </a:defRPr>
            </a:lvl3pPr>
            <a:lvl4pPr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游ゴシック Light" panose="020B0300000000000000" pitchFamily="50" charset="-128"/>
                <a:ea typeface="游ゴシック Light" panose="020B0300000000000000" pitchFamily="50" charset="-128"/>
              </a:defRPr>
            </a:lvl4pPr>
            <a:lvl5pPr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游ゴシック Light" panose="020B0300000000000000" pitchFamily="50" charset="-128"/>
                <a:ea typeface="游ゴシック Light" panose="020B0300000000000000" pitchFamily="50" charset="-128"/>
              </a:defRPr>
            </a:lvl5pPr>
            <a:lvl6pPr marL="4572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游ゴシック Light" panose="020B0300000000000000" pitchFamily="50" charset="-128"/>
                <a:ea typeface="游ゴシック Light" panose="020B0300000000000000" pitchFamily="50" charset="-128"/>
              </a:defRPr>
            </a:lvl6pPr>
            <a:lvl7pPr marL="9144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游ゴシック Light" panose="020B0300000000000000" pitchFamily="50" charset="-128"/>
                <a:ea typeface="游ゴシック Light" panose="020B0300000000000000" pitchFamily="50" charset="-128"/>
              </a:defRPr>
            </a:lvl7pPr>
            <a:lvl8pPr marL="13716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游ゴシック Light" panose="020B0300000000000000" pitchFamily="50" charset="-128"/>
                <a:ea typeface="游ゴシック Light" panose="020B0300000000000000" pitchFamily="50" charset="-128"/>
              </a:defRPr>
            </a:lvl8pPr>
            <a:lvl9pPr marL="18288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kumimoji="1" sz="4400">
                <a:solidFill>
                  <a:schemeClr val="tx1"/>
                </a:solidFill>
                <a:latin typeface="游ゴシック Light" panose="020B0300000000000000" pitchFamily="50" charset="-128"/>
                <a:ea typeface="游ゴシック Light" panose="020B0300000000000000" pitchFamily="50" charset="-128"/>
              </a:defRPr>
            </a:lvl9pPr>
          </a:lstStyle>
          <a:p>
            <a:pPr eaLnBrk="1" hangingPunct="1"/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9EE5E66-400C-41F4-94ED-60B297F6C298}"/>
              </a:ext>
            </a:extLst>
          </p:cNvPr>
          <p:cNvSpPr txBox="1"/>
          <p:nvPr/>
        </p:nvSpPr>
        <p:spPr>
          <a:xfrm>
            <a:off x="932278" y="106741"/>
            <a:ext cx="1094473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ja-JP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A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altLang="ja-JP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ronuclei formation of</a:t>
            </a:r>
            <a:r>
              <a:rPr lang="en-GB" altLang="ja-JP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549</a:t>
            </a:r>
            <a:r>
              <a:rPr lang="en-GB" altLang="ja-JP" sz="2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ells after administration of vinorelbine or paclitaxel with 8 Gy/4 fr irradiation. 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4D2D683-EE25-44F9-B029-CE2152969E0F}"/>
              </a:ext>
            </a:extLst>
          </p:cNvPr>
          <p:cNvSpPr txBox="1"/>
          <p:nvPr/>
        </p:nvSpPr>
        <p:spPr>
          <a:xfrm>
            <a:off x="1309681" y="5062467"/>
            <a:ext cx="800452" cy="318924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on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CE8A6F6F-4D04-4D9B-9E40-FF3F08D37C0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2172" t="-29682" r="32172" b="29682"/>
          <a:stretch/>
        </p:blipFill>
        <p:spPr>
          <a:xfrm>
            <a:off x="5155350" y="3324457"/>
            <a:ext cx="3668646" cy="321006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8733E9DF-CCED-44E5-A677-8CEF5C7125C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-2904" r="2904"/>
          <a:stretch/>
        </p:blipFill>
        <p:spPr>
          <a:xfrm>
            <a:off x="8786696" y="1410043"/>
            <a:ext cx="2652830" cy="2321226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70342EC1-3884-4B62-B544-B3DD7413F80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926" t="-3720" r="33724" b="29974"/>
          <a:stretch/>
        </p:blipFill>
        <p:spPr>
          <a:xfrm>
            <a:off x="243527" y="2473125"/>
            <a:ext cx="2880000" cy="2520000"/>
          </a:xfrm>
          <a:prstGeom prst="rect">
            <a:avLst/>
          </a:prstGeom>
        </p:spPr>
      </p:pic>
      <p:pic>
        <p:nvPicPr>
          <p:cNvPr id="4" name="図 3"/>
          <p:cNvPicPr preferRelativeResize="0"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627" t="-21678" r="25627" b="21678"/>
          <a:stretch/>
        </p:blipFill>
        <p:spPr>
          <a:xfrm>
            <a:off x="5418475" y="784775"/>
            <a:ext cx="3367421" cy="2946494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6D42FE74-C296-4661-B754-BEBBA98B93B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80114" y="2580035"/>
            <a:ext cx="2318992" cy="24198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58559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0485AE79-6D8D-41EE-913C-66E969CCCC73}"/>
              </a:ext>
            </a:extLst>
          </p:cNvPr>
          <p:cNvGrpSpPr/>
          <p:nvPr/>
        </p:nvGrpSpPr>
        <p:grpSpPr>
          <a:xfrm>
            <a:off x="2109514" y="4188417"/>
            <a:ext cx="8011059" cy="2540327"/>
            <a:chOff x="1475841" y="4159859"/>
            <a:chExt cx="7682775" cy="2540327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5335" y="4722818"/>
              <a:ext cx="7343281" cy="1860686"/>
            </a:xfrm>
            <a:prstGeom prst="rect">
              <a:avLst/>
            </a:prstGeom>
          </p:spPr>
        </p:pic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C27D3824-8B00-4665-BA7B-FCF93CF83FEB}"/>
                </a:ext>
              </a:extLst>
            </p:cNvPr>
            <p:cNvCxnSpPr>
              <a:cxnSpLocks/>
            </p:cNvCxnSpPr>
            <p:nvPr/>
          </p:nvCxnSpPr>
          <p:spPr>
            <a:xfrm>
              <a:off x="4688516" y="5018622"/>
              <a:ext cx="0" cy="1388191"/>
            </a:xfrm>
            <a:prstGeom prst="line">
              <a:avLst/>
            </a:prstGeom>
            <a:ln w="3810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160BCE0E-D262-455E-8375-C80CB2FD7E23}"/>
                </a:ext>
              </a:extLst>
            </p:cNvPr>
            <p:cNvSpPr txBox="1"/>
            <p:nvPr/>
          </p:nvSpPr>
          <p:spPr>
            <a:xfrm>
              <a:off x="1962562" y="6361632"/>
              <a:ext cx="12570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/>
                <a:t>Interphase</a:t>
              </a:r>
              <a:endParaRPr kumimoji="1" lang="ja-JP" altLang="en-US" sz="1600" b="1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3CEE9731-B12C-4D68-899D-891DD6C97E74}"/>
                </a:ext>
              </a:extLst>
            </p:cNvPr>
            <p:cNvSpPr txBox="1"/>
            <p:nvPr/>
          </p:nvSpPr>
          <p:spPr>
            <a:xfrm>
              <a:off x="3438321" y="6361632"/>
              <a:ext cx="11304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/>
                <a:t>P</a:t>
              </a:r>
              <a:r>
                <a:rPr kumimoji="1" lang="en-US" altLang="ja-JP" sz="1600" b="1" dirty="0"/>
                <a:t>rophase</a:t>
              </a:r>
              <a:endParaRPr kumimoji="1" lang="ja-JP" altLang="en-US" sz="1600" b="1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B574BCD-BC69-42A5-8154-EC9EE6EB917E}"/>
                </a:ext>
              </a:extLst>
            </p:cNvPr>
            <p:cNvSpPr txBox="1"/>
            <p:nvPr/>
          </p:nvSpPr>
          <p:spPr>
            <a:xfrm>
              <a:off x="4787443" y="6361632"/>
              <a:ext cx="13003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/>
                <a:t>M</a:t>
              </a:r>
              <a:r>
                <a:rPr kumimoji="1" lang="en-US" altLang="ja-JP" sz="1600" b="1" dirty="0"/>
                <a:t>etaphase</a:t>
              </a:r>
              <a:endParaRPr kumimoji="1" lang="ja-JP" altLang="en-US" sz="1600" b="1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1616DCC7-FDFB-447F-86F3-9EAA9FFBD0CA}"/>
                </a:ext>
              </a:extLst>
            </p:cNvPr>
            <p:cNvSpPr txBox="1"/>
            <p:nvPr/>
          </p:nvSpPr>
          <p:spPr>
            <a:xfrm>
              <a:off x="7698885" y="6361632"/>
              <a:ext cx="12218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err="1"/>
                <a:t>Telophase</a:t>
              </a:r>
              <a:endParaRPr kumimoji="1" lang="ja-JP" altLang="en-US" sz="1600" b="1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849DCDC-69C9-4584-A156-2A5A66942FDC}"/>
                </a:ext>
              </a:extLst>
            </p:cNvPr>
            <p:cNvSpPr txBox="1"/>
            <p:nvPr/>
          </p:nvSpPr>
          <p:spPr>
            <a:xfrm>
              <a:off x="6306483" y="6361632"/>
              <a:ext cx="11737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/>
                <a:t>A</a:t>
              </a:r>
              <a:r>
                <a:rPr kumimoji="1" lang="en-US" altLang="ja-JP" sz="1600" b="1" dirty="0"/>
                <a:t>naphase</a:t>
              </a:r>
              <a:endParaRPr kumimoji="1" lang="ja-JP" altLang="en-US" sz="1600" b="1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74C3CB07-DAA1-466F-9A3F-E99AFEB55ED7}"/>
                </a:ext>
              </a:extLst>
            </p:cNvPr>
            <p:cNvSpPr txBox="1"/>
            <p:nvPr/>
          </p:nvSpPr>
          <p:spPr>
            <a:xfrm>
              <a:off x="1475841" y="4166819"/>
              <a:ext cx="10342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/>
                <a:t>CDK1/2i</a:t>
              </a:r>
              <a:endParaRPr kumimoji="1" lang="ja-JP" altLang="en-US" sz="1600" b="1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5A4D37ED-D9B0-4747-B82D-33575FACE8B1}"/>
                </a:ext>
              </a:extLst>
            </p:cNvPr>
            <p:cNvSpPr txBox="1"/>
            <p:nvPr/>
          </p:nvSpPr>
          <p:spPr>
            <a:xfrm>
              <a:off x="5085028" y="4166819"/>
              <a:ext cx="7970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 err="1"/>
                <a:t>AurB</a:t>
              </a:r>
              <a:r>
                <a:rPr kumimoji="1" lang="en-US" altLang="ja-JP" sz="1600" b="1" dirty="0"/>
                <a:t> </a:t>
              </a:r>
              <a:r>
                <a:rPr kumimoji="1" lang="en-US" altLang="ja-JP" sz="1600" b="1" dirty="0" err="1"/>
                <a:t>i</a:t>
              </a:r>
              <a:endParaRPr kumimoji="1" lang="ja-JP" altLang="en-US" sz="1600" b="1" dirty="0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28E05315-8A8B-40DA-82C2-269A4DCE50B1}"/>
                </a:ext>
              </a:extLst>
            </p:cNvPr>
            <p:cNvSpPr txBox="1"/>
            <p:nvPr/>
          </p:nvSpPr>
          <p:spPr>
            <a:xfrm>
              <a:off x="2906281" y="4159859"/>
              <a:ext cx="79220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 err="1"/>
                <a:t>AurA</a:t>
              </a:r>
              <a:r>
                <a:rPr lang="en-US" altLang="ja-JP" sz="1600" b="1" dirty="0"/>
                <a:t> </a:t>
              </a:r>
              <a:r>
                <a:rPr kumimoji="1" lang="en-US" altLang="ja-JP" sz="1600" b="1" dirty="0" err="1"/>
                <a:t>i</a:t>
              </a:r>
              <a:endParaRPr kumimoji="1" lang="ja-JP" altLang="en-US" sz="1600" b="1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07BFEA77-0EF2-47CC-9474-612763D78933}"/>
                </a:ext>
              </a:extLst>
            </p:cNvPr>
            <p:cNvSpPr txBox="1"/>
            <p:nvPr/>
          </p:nvSpPr>
          <p:spPr>
            <a:xfrm>
              <a:off x="4116331" y="4166819"/>
              <a:ext cx="6303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/>
                <a:t>VNR</a:t>
              </a:r>
              <a:endParaRPr kumimoji="1" lang="ja-JP" altLang="en-US" sz="1600" b="1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DC718B72-B9D3-45DE-B69A-6501BC5EFD51}"/>
                </a:ext>
              </a:extLst>
            </p:cNvPr>
            <p:cNvSpPr txBox="1"/>
            <p:nvPr/>
          </p:nvSpPr>
          <p:spPr>
            <a:xfrm>
              <a:off x="6489659" y="4162080"/>
              <a:ext cx="64793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/>
                <a:t>DOC</a:t>
              </a:r>
              <a:endParaRPr kumimoji="1" lang="ja-JP" altLang="en-US" sz="1600" b="1" dirty="0"/>
            </a:p>
          </p:txBody>
        </p:sp>
        <p:sp>
          <p:nvSpPr>
            <p:cNvPr id="9" name="矢印: 下 8">
              <a:extLst>
                <a:ext uri="{FF2B5EF4-FFF2-40B4-BE49-F238E27FC236}">
                  <a16:creationId xmlns:a16="http://schemas.microsoft.com/office/drawing/2014/main" id="{92360155-243E-46FA-9960-580AE7AF335F}"/>
                </a:ext>
              </a:extLst>
            </p:cNvPr>
            <p:cNvSpPr/>
            <p:nvPr/>
          </p:nvSpPr>
          <p:spPr>
            <a:xfrm>
              <a:off x="5172740" y="4498413"/>
              <a:ext cx="525780" cy="400050"/>
            </a:xfrm>
            <a:prstGeom prst="down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" name="矢印: 下 23">
              <a:extLst>
                <a:ext uri="{FF2B5EF4-FFF2-40B4-BE49-F238E27FC236}">
                  <a16:creationId xmlns:a16="http://schemas.microsoft.com/office/drawing/2014/main" id="{0852EB84-EF96-47B2-B1BB-64E0EA6000F9}"/>
                </a:ext>
              </a:extLst>
            </p:cNvPr>
            <p:cNvSpPr/>
            <p:nvPr/>
          </p:nvSpPr>
          <p:spPr>
            <a:xfrm>
              <a:off x="1730080" y="4498413"/>
              <a:ext cx="525780" cy="400050"/>
            </a:xfrm>
            <a:prstGeom prst="down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矢印: 下 24">
              <a:extLst>
                <a:ext uri="{FF2B5EF4-FFF2-40B4-BE49-F238E27FC236}">
                  <a16:creationId xmlns:a16="http://schemas.microsoft.com/office/drawing/2014/main" id="{6344E839-0C82-44D3-BFC4-3789487B165A}"/>
                </a:ext>
              </a:extLst>
            </p:cNvPr>
            <p:cNvSpPr/>
            <p:nvPr/>
          </p:nvSpPr>
          <p:spPr>
            <a:xfrm>
              <a:off x="2994132" y="4498413"/>
              <a:ext cx="525780" cy="400050"/>
            </a:xfrm>
            <a:prstGeom prst="down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" name="矢印: 下 25">
              <a:extLst>
                <a:ext uri="{FF2B5EF4-FFF2-40B4-BE49-F238E27FC236}">
                  <a16:creationId xmlns:a16="http://schemas.microsoft.com/office/drawing/2014/main" id="{A1074A75-0BD0-4F1C-9D26-15217DD7EA66}"/>
                </a:ext>
              </a:extLst>
            </p:cNvPr>
            <p:cNvSpPr/>
            <p:nvPr/>
          </p:nvSpPr>
          <p:spPr>
            <a:xfrm>
              <a:off x="4144922" y="4498413"/>
              <a:ext cx="525780" cy="400050"/>
            </a:xfrm>
            <a:prstGeom prst="down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" name="矢印: 下 26">
              <a:extLst>
                <a:ext uri="{FF2B5EF4-FFF2-40B4-BE49-F238E27FC236}">
                  <a16:creationId xmlns:a16="http://schemas.microsoft.com/office/drawing/2014/main" id="{8AA674C2-DF46-4BEA-98DD-2C0EF55E031D}"/>
                </a:ext>
              </a:extLst>
            </p:cNvPr>
            <p:cNvSpPr/>
            <p:nvPr/>
          </p:nvSpPr>
          <p:spPr>
            <a:xfrm>
              <a:off x="6550736" y="4498413"/>
              <a:ext cx="525780" cy="400050"/>
            </a:xfrm>
            <a:prstGeom prst="down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CAA1372F-6801-4A78-AF86-6313AFF2E2D9}"/>
              </a:ext>
            </a:extLst>
          </p:cNvPr>
          <p:cNvGraphicFramePr>
            <a:graphicFrameLocks/>
          </p:cNvGraphicFramePr>
          <p:nvPr/>
        </p:nvGraphicFramePr>
        <p:xfrm>
          <a:off x="1524560" y="974734"/>
          <a:ext cx="8191732" cy="30132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678E398D-24B1-4345-BB99-AC29B289F6A2}"/>
              </a:ext>
            </a:extLst>
          </p:cNvPr>
          <p:cNvCxnSpPr>
            <a:cxnSpLocks/>
          </p:cNvCxnSpPr>
          <p:nvPr/>
        </p:nvCxnSpPr>
        <p:spPr>
          <a:xfrm flipV="1">
            <a:off x="1943598" y="2027144"/>
            <a:ext cx="7630510" cy="10511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581EFF7-C7B4-4573-8662-7F53E940DCA4}"/>
              </a:ext>
            </a:extLst>
          </p:cNvPr>
          <p:cNvSpPr txBox="1"/>
          <p:nvPr/>
        </p:nvSpPr>
        <p:spPr>
          <a:xfrm>
            <a:off x="1524560" y="129256"/>
            <a:ext cx="914287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Figure 3B</a:t>
            </a:r>
          </a:p>
          <a:p>
            <a:r>
              <a:rPr lang="en-US" altLang="ja-JP" sz="2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omparison of ISRE activities observed with treatment of different kinds of cell cycle inhibitors combined with irradiation </a:t>
            </a:r>
          </a:p>
        </p:txBody>
      </p:sp>
      <p:sp>
        <p:nvSpPr>
          <p:cNvPr id="10" name="テキスト ボックス 60">
            <a:extLst>
              <a:ext uri="{FF2B5EF4-FFF2-40B4-BE49-F238E27FC236}">
                <a16:creationId xmlns:a16="http://schemas.microsoft.com/office/drawing/2014/main" id="{6CDDE1BB-0717-4290-B969-AD79B7EBB82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23632" y="2178864"/>
            <a:ext cx="180197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algn="ctr" eaLnBrk="1" hangingPunct="1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value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828E554-F695-41ED-9A69-7C64C95DD6D0}"/>
              </a:ext>
            </a:extLst>
          </p:cNvPr>
          <p:cNvSpPr txBox="1"/>
          <p:nvPr/>
        </p:nvSpPr>
        <p:spPr>
          <a:xfrm>
            <a:off x="9119654" y="1131607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65251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A4FDD728-D3A0-419C-A067-B933D25CFB1F}"/>
              </a:ext>
            </a:extLst>
          </p:cNvPr>
          <p:cNvCxnSpPr>
            <a:cxnSpLocks/>
          </p:cNvCxnSpPr>
          <p:nvPr/>
        </p:nvCxnSpPr>
        <p:spPr>
          <a:xfrm>
            <a:off x="2181225" y="3835619"/>
            <a:ext cx="8807669" cy="21021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60">
            <a:extLst>
              <a:ext uri="{FF2B5EF4-FFF2-40B4-BE49-F238E27FC236}">
                <a16:creationId xmlns:a16="http://schemas.microsoft.com/office/drawing/2014/main" id="{C67F7A5A-22A0-4BD9-B336-B3FDC3D9E54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01803" y="3792011"/>
            <a:ext cx="180197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algn="ctr" eaLnBrk="1" hangingPunct="1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value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CD0B500-044F-49FA-87F9-FCBC1B5D9AE2}"/>
              </a:ext>
            </a:extLst>
          </p:cNvPr>
          <p:cNvSpPr txBox="1"/>
          <p:nvPr/>
        </p:nvSpPr>
        <p:spPr>
          <a:xfrm>
            <a:off x="1661832" y="424045"/>
            <a:ext cx="867671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Figure 4</a:t>
            </a:r>
          </a:p>
          <a:p>
            <a:r>
              <a:rPr lang="en-US" altLang="ja-JP" sz="2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omparison of ISRE activities with treatment of different kinds of molecular target drugs combined with IR</a:t>
            </a: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0E6C06CE-34B2-44AB-A614-69CB4DE11FC1}"/>
              </a:ext>
            </a:extLst>
          </p:cNvPr>
          <p:cNvGraphicFramePr>
            <a:graphicFrameLocks/>
          </p:cNvGraphicFramePr>
          <p:nvPr/>
        </p:nvGraphicFramePr>
        <p:xfrm>
          <a:off x="1555531" y="1488621"/>
          <a:ext cx="9893520" cy="49453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35E1A8C-D840-4DE2-B6E2-ED2335CF27DB}"/>
              </a:ext>
            </a:extLst>
          </p:cNvPr>
          <p:cNvSpPr txBox="1"/>
          <p:nvPr/>
        </p:nvSpPr>
        <p:spPr>
          <a:xfrm>
            <a:off x="10852413" y="1698562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7365765"/>
      </p:ext>
    </p:extLst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B797F80B-9DDE-41E6-A88E-81C1DEB4D5B3}"/>
              </a:ext>
            </a:extLst>
          </p:cNvPr>
          <p:cNvGraphicFramePr>
            <a:graphicFrameLocks/>
          </p:cNvGraphicFramePr>
          <p:nvPr/>
        </p:nvGraphicFramePr>
        <p:xfrm>
          <a:off x="1248895" y="1767004"/>
          <a:ext cx="9268227" cy="44922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B9DBE14C-5BB1-42CD-BDDE-F183FE9AF890}"/>
              </a:ext>
            </a:extLst>
          </p:cNvPr>
          <p:cNvCxnSpPr>
            <a:cxnSpLocks/>
          </p:cNvCxnSpPr>
          <p:nvPr/>
        </p:nvCxnSpPr>
        <p:spPr>
          <a:xfrm>
            <a:off x="1687658" y="2969168"/>
            <a:ext cx="8523889" cy="10511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CB3EFA0-538C-4307-A68B-40F999E0FFC3}"/>
              </a:ext>
            </a:extLst>
          </p:cNvPr>
          <p:cNvSpPr txBox="1"/>
          <p:nvPr/>
        </p:nvSpPr>
        <p:spPr>
          <a:xfrm>
            <a:off x="1248895" y="332794"/>
            <a:ext cx="1018278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altLang="ja-JP" sz="2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Figure </a:t>
            </a:r>
            <a:r>
              <a:rPr lang="en-GB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</a:p>
          <a:p>
            <a:pPr algn="just"/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mparison of ISRE activities observed with treatment of different kinds of anti-inflammatory and immunology drugs that are clinically used in combination with IR. </a:t>
            </a:r>
          </a:p>
        </p:txBody>
      </p:sp>
      <p:sp>
        <p:nvSpPr>
          <p:cNvPr id="2" name="テキスト ボックス 60">
            <a:extLst>
              <a:ext uri="{FF2B5EF4-FFF2-40B4-BE49-F238E27FC236}">
                <a16:creationId xmlns:a16="http://schemas.microsoft.com/office/drawing/2014/main" id="{6B967C5D-4556-48ED-A3E7-0607C4FAFA3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78631" y="3259723"/>
            <a:ext cx="180197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algn="ctr" eaLnBrk="1" hangingPunct="1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value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84E6934-4DFF-4069-9EAE-76CA0FB2F29D}"/>
              </a:ext>
            </a:extLst>
          </p:cNvPr>
          <p:cNvSpPr txBox="1"/>
          <p:nvPr/>
        </p:nvSpPr>
        <p:spPr>
          <a:xfrm>
            <a:off x="9913228" y="1908112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3630288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</TotalTime>
  <Words>182</Words>
  <Application>Microsoft Office PowerPoint</Application>
  <PresentationFormat>ワイド画面</PresentationFormat>
  <Paragraphs>46</Paragraphs>
  <Slides>7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2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奥村 真之</dc:creator>
  <cp:lastModifiedBy>影山</cp:lastModifiedBy>
  <cp:revision>9</cp:revision>
  <dcterms:created xsi:type="dcterms:W3CDTF">2020-10-25T09:15:41Z</dcterms:created>
  <dcterms:modified xsi:type="dcterms:W3CDTF">2021-09-26T06:05:01Z</dcterms:modified>
</cp:coreProperties>
</file>